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CB7567-3A60-FB11-4206-E3A47087E0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5C7AB40-90BD-B652-CB8B-4053609738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7675ED-31DB-1BBF-4D24-390BF6CAA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586A8A-EEBD-3C4B-B947-00C61CD042FD}" type="datetimeFigureOut">
              <a:rPr lang="en-US" smtClean="0"/>
              <a:t>12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1D4D11-B552-ADF9-3165-5C6F8E1A9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472708-FAB1-8307-82F1-9131D41BF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34403-2614-AF42-AF83-BD24DA951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220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FAD8E-EAF4-5C63-619D-269E5A1A4B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764F8EF-E6BF-CB12-B705-085AE77426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01110C-355F-2A19-83C3-F13FFDF416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586A8A-EEBD-3C4B-B947-00C61CD042FD}" type="datetimeFigureOut">
              <a:rPr lang="en-US" smtClean="0"/>
              <a:t>12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EE1F57-615D-2D1E-F7F7-DE952CC0C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6D14C5-4C19-B27E-5460-9BDA4CD92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34403-2614-AF42-AF83-BD24DA951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6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38642C6-1516-EE23-3CE4-C80AE2D2D0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D54A14-33BF-6CB9-B476-48EB495C10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4F45A3-7EDC-CB07-F3A9-FB18C584A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586A8A-EEBD-3C4B-B947-00C61CD042FD}" type="datetimeFigureOut">
              <a:rPr lang="en-US" smtClean="0"/>
              <a:t>12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876A63-0A98-5466-F649-E2EB282294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93F687-0292-A815-71F1-2528A22C8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34403-2614-AF42-AF83-BD24DA951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256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B7EB43-E377-65F8-7AE7-F78DC8E3C7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D42169-5B51-28C4-F6DA-DCBEC58855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E5EB09-810F-AC59-BFCA-8AFC45DE8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586A8A-EEBD-3C4B-B947-00C61CD042FD}" type="datetimeFigureOut">
              <a:rPr lang="en-US" smtClean="0"/>
              <a:t>12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8188DA-6AFB-CFBC-AB79-AA6F181E6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C7252E-7B24-AE00-8414-8C4BABD5C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34403-2614-AF42-AF83-BD24DA951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922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87628F-8010-6394-5F0B-FB7C693615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A11724-9F8F-A166-C621-AA033D7038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152E66-A430-BC1F-6F8B-27E4966F6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586A8A-EEBD-3C4B-B947-00C61CD042FD}" type="datetimeFigureOut">
              <a:rPr lang="en-US" smtClean="0"/>
              <a:t>12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C283EF-98AC-F613-2169-7CFD65F717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FA0885-CDBD-0132-10DC-809AA4551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34403-2614-AF42-AF83-BD24DA951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771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CF9D2F-BB58-3E05-B365-F4EBF1EF0F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7D7BB7-3B0E-B9F1-D52A-324E6E1382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244B9EE-43B5-4AF5-3216-EC6C19322E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B847AD-7D97-B7A5-C9F2-56C5F1992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586A8A-EEBD-3C4B-B947-00C61CD042FD}" type="datetimeFigureOut">
              <a:rPr lang="en-US" smtClean="0"/>
              <a:t>12/1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69669B-F737-4ECE-4BB3-0B6E987BF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3CEE17-B6B1-D888-CE7C-06FDF479B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34403-2614-AF42-AF83-BD24DA951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66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F79381-861B-EF22-BB2B-E639507318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8BF0F5-3F58-F567-B947-C6F2BE5FDA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18E8B17-DCFB-5732-60CC-07495FFBFE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3CE8A5A-53DB-7BFF-93A0-C38157FAE6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F026C3-D26D-1EA2-12F8-0536A47E4E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D17184-516F-C990-31FC-1C8594AF76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586A8A-EEBD-3C4B-B947-00C61CD042FD}" type="datetimeFigureOut">
              <a:rPr lang="en-US" smtClean="0"/>
              <a:t>12/12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B513FD1-7FAB-8ECD-1983-E200ADFBCA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C019403-3137-10F2-1CDC-45F3AA342F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34403-2614-AF42-AF83-BD24DA951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921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CA167C-705F-50C2-EC9D-44063C6A2B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EA13C4-6864-7E0C-C860-85541C2AD9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586A8A-EEBD-3C4B-B947-00C61CD042FD}" type="datetimeFigureOut">
              <a:rPr lang="en-US" smtClean="0"/>
              <a:t>12/12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FAD0EF6-9D4C-C7C0-C593-FB732FCFE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B978B10-4EAF-FF91-F2D5-B0FC68354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34403-2614-AF42-AF83-BD24DA951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689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1CE9FED-B3C1-4396-EB2A-B0D2625417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586A8A-EEBD-3C4B-B947-00C61CD042FD}" type="datetimeFigureOut">
              <a:rPr lang="en-US" smtClean="0"/>
              <a:t>12/12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1BB57C2-F4DB-266F-F400-1BBC06B0FE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D379B12-B4EF-01E8-0599-F5E8DA2586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34403-2614-AF42-AF83-BD24DA951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894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982A4A-D755-CCF9-E1F4-4293B455CE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491A00-C933-1AE2-26A7-AF1CA87CE8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A2400E-7B49-D19B-B05F-FB1295C109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8EC5F1-2672-73EE-8D3B-E419DA6133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586A8A-EEBD-3C4B-B947-00C61CD042FD}" type="datetimeFigureOut">
              <a:rPr lang="en-US" smtClean="0"/>
              <a:t>12/1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07E257-C280-52A1-3F47-4901009606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8B59E6-C5A5-69BB-16FC-7C16272B5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34403-2614-AF42-AF83-BD24DA951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442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FFB962-A2EF-AF34-06DA-77440DB5B5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F67DD36-B7B9-47F8-A615-DC9DC037F0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67BEDD-D027-A7E4-C163-C6CCAE0B38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EC7AD4-D633-DF9A-0B59-B60A5D1DA5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586A8A-EEBD-3C4B-B947-00C61CD042FD}" type="datetimeFigureOut">
              <a:rPr lang="en-US" smtClean="0"/>
              <a:t>12/1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040C57-FF21-F23D-B2C5-789A9533CB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E50845-65CC-7E54-E435-EF6AF0EBAB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634403-2614-AF42-AF83-BD24DA951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8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08CFD57-2549-8100-D664-90B906C233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009FD9-3644-A647-5E4E-3DF232CD39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AFFCCC-1D99-2DC8-ED0E-15918662FE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586A8A-EEBD-3C4B-B947-00C61CD042FD}" type="datetimeFigureOut">
              <a:rPr lang="en-US" smtClean="0"/>
              <a:t>12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A7EF37-1270-47E9-B540-9A84F8E511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9610F9-C28A-E8EC-5468-EE60ED791A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634403-2614-AF42-AF83-BD24DA9514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573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858C1BC-9E8A-DBF5-3DAC-FD7276F312A3}"/>
              </a:ext>
            </a:extLst>
          </p:cNvPr>
          <p:cNvSpPr txBox="1"/>
          <p:nvPr/>
        </p:nvSpPr>
        <p:spPr>
          <a:xfrm>
            <a:off x="273269" y="124543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0279AE5-1ABB-3054-E2F7-F3FB0F38E484}"/>
              </a:ext>
            </a:extLst>
          </p:cNvPr>
          <p:cNvSpPr txBox="1"/>
          <p:nvPr/>
        </p:nvSpPr>
        <p:spPr>
          <a:xfrm>
            <a:off x="294287" y="581009"/>
            <a:ext cx="4961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B6FDBD4-BAF8-0806-4C4A-084C5D5709A5}"/>
              </a:ext>
            </a:extLst>
          </p:cNvPr>
          <p:cNvSpPr txBox="1"/>
          <p:nvPr/>
        </p:nvSpPr>
        <p:spPr>
          <a:xfrm>
            <a:off x="7494476" y="1112199"/>
            <a:ext cx="414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35D221E-BE53-C85A-8988-2DB310DA9C4C}"/>
              </a:ext>
            </a:extLst>
          </p:cNvPr>
          <p:cNvSpPr txBox="1"/>
          <p:nvPr/>
        </p:nvSpPr>
        <p:spPr>
          <a:xfrm>
            <a:off x="7496864" y="3561373"/>
            <a:ext cx="409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DBAFC242-7D93-2E26-9BA3-A648C6BACF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333" y="581007"/>
            <a:ext cx="6766683" cy="482130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D9477FB-D3BF-EA41-87EF-60151B0C93F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117" t="2727" r="5736" b="37426"/>
          <a:stretch/>
        </p:blipFill>
        <p:spPr>
          <a:xfrm>
            <a:off x="8145905" y="1321113"/>
            <a:ext cx="2154234" cy="218579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717E819-CF5E-87AB-F537-9FFBCC7EDE54}"/>
              </a:ext>
            </a:extLst>
          </p:cNvPr>
          <p:cNvSpPr txBox="1"/>
          <p:nvPr/>
        </p:nvSpPr>
        <p:spPr>
          <a:xfrm>
            <a:off x="8597463" y="1086086"/>
            <a:ext cx="7452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roban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AD3D545-6E19-4505-3A54-1A74BD9576A3}"/>
              </a:ext>
            </a:extLst>
          </p:cNvPr>
          <p:cNvSpPr txBox="1"/>
          <p:nvPr/>
        </p:nvSpPr>
        <p:spPr>
          <a:xfrm>
            <a:off x="9372925" y="1088523"/>
            <a:ext cx="5325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o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800DE9D-4BDD-8688-26FE-EA71F7CA2EC9}"/>
              </a:ext>
            </a:extLst>
          </p:cNvPr>
          <p:cNvSpPr txBox="1"/>
          <p:nvPr/>
        </p:nvSpPr>
        <p:spPr>
          <a:xfrm>
            <a:off x="9868918" y="108608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da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0D7E932-BD82-6856-5DB5-34A8D3C13766}"/>
              </a:ext>
            </a:extLst>
          </p:cNvPr>
          <p:cNvSpPr txBox="1"/>
          <p:nvPr/>
        </p:nvSpPr>
        <p:spPr>
          <a:xfrm>
            <a:off x="10300139" y="2441967"/>
            <a:ext cx="635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64 bp</a:t>
            </a:r>
          </a:p>
        </p:txBody>
      </p:sp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605D2058-9ECA-DA9C-653B-527C1DD034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51240771"/>
              </p:ext>
            </p:extLst>
          </p:nvPr>
        </p:nvGraphicFramePr>
        <p:xfrm>
          <a:off x="7891042" y="3846623"/>
          <a:ext cx="3705011" cy="162647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41091">
                  <a:extLst>
                    <a:ext uri="{9D8B030D-6E8A-4147-A177-3AD203B41FA5}">
                      <a16:colId xmlns:a16="http://schemas.microsoft.com/office/drawing/2014/main" val="1024649218"/>
                    </a:ext>
                  </a:extLst>
                </a:gridCol>
                <a:gridCol w="1019094">
                  <a:extLst>
                    <a:ext uri="{9D8B030D-6E8A-4147-A177-3AD203B41FA5}">
                      <a16:colId xmlns:a16="http://schemas.microsoft.com/office/drawing/2014/main" val="3695632863"/>
                    </a:ext>
                  </a:extLst>
                </a:gridCol>
                <a:gridCol w="925320">
                  <a:extLst>
                    <a:ext uri="{9D8B030D-6E8A-4147-A177-3AD203B41FA5}">
                      <a16:colId xmlns:a16="http://schemas.microsoft.com/office/drawing/2014/main" val="32644108"/>
                    </a:ext>
                  </a:extLst>
                </a:gridCol>
                <a:gridCol w="1019506">
                  <a:extLst>
                    <a:ext uri="{9D8B030D-6E8A-4147-A177-3AD203B41FA5}">
                      <a16:colId xmlns:a16="http://schemas.microsoft.com/office/drawing/2014/main" val="2095981474"/>
                    </a:ext>
                  </a:extLst>
                </a:gridCol>
              </a:tblGrid>
              <a:tr h="256139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WT allel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GT Del allel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G118D allel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16133821"/>
                  </a:ext>
                </a:extLst>
              </a:tr>
              <a:tr h="47305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Proband, </a:t>
                      </a:r>
                    </a:p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sample 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N/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230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(18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1440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(82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72797055"/>
                  </a:ext>
                </a:extLst>
              </a:tr>
              <a:tr h="47305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Proband, </a:t>
                      </a:r>
                    </a:p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sample 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N/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273 (18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1499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(82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82065399"/>
                  </a:ext>
                </a:extLst>
              </a:tr>
              <a:tr h="42422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Contro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1579 </a:t>
                      </a:r>
                    </a:p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(100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N/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N/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86552542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612B8B73-6D6D-C542-AFC4-F4FEE7F59F0E}"/>
              </a:ext>
            </a:extLst>
          </p:cNvPr>
          <p:cNvSpPr txBox="1"/>
          <p:nvPr/>
        </p:nvSpPr>
        <p:spPr>
          <a:xfrm>
            <a:off x="595946" y="5637644"/>
            <a:ext cx="1100010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1</a:t>
            </a:r>
            <a:r>
              <a:rPr lang="en-US" sz="1200" dirty="0"/>
              <a:t>: RNA studies.  </a:t>
            </a:r>
            <a:r>
              <a:rPr lang="en-US" sz="1200" b="1" dirty="0"/>
              <a:t>A. </a:t>
            </a:r>
            <a:r>
              <a:rPr lang="en-US" sz="1200" dirty="0"/>
              <a:t>Splicing prediction in Alamut Software. Variant allele shows a mild decrease in 3’ splice site strength.</a:t>
            </a:r>
            <a:r>
              <a:rPr lang="en-US" sz="1200" b="1" dirty="0"/>
              <a:t> B. </a:t>
            </a:r>
            <a:r>
              <a:rPr lang="en-US" sz="1200" dirty="0"/>
              <a:t>Primers used to amplify exons 1-4 of COQ5 cDNA. </a:t>
            </a:r>
            <a:r>
              <a:rPr lang="en-US" sz="1200" b="1" dirty="0"/>
              <a:t>C. </a:t>
            </a:r>
            <a:r>
              <a:rPr lang="en-US" sz="1200" dirty="0"/>
              <a:t>Agarose gel electrophoresis of exons 1-4 of COQ5 cDNA PCR from proband. Lane 1: DNA ladder, lanes 2-3: Proband, lane 4: mom, lane 5: dad. </a:t>
            </a:r>
            <a:r>
              <a:rPr lang="en-US" sz="1200" b="1" dirty="0"/>
              <a:t>D. </a:t>
            </a:r>
            <a:r>
              <a:rPr lang="en-US" sz="1200" dirty="0"/>
              <a:t>Deep next generation sequencing of cDNA PCR product. No alternative splicing was seen in 2 proband samples nor a control sample, despite sequencing to depths of &gt; 1500 reads. 82% of reads contained the G118D mutant allele, while only 18% of reads contained the GT deletion allele, confirming degradation of the GT deletion allele, likely due to nonsense mediated decay.</a:t>
            </a:r>
            <a:endParaRPr lang="en-US" sz="12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382CB4F-F95E-3462-04F3-8B712DD6D0BB}"/>
              </a:ext>
            </a:extLst>
          </p:cNvPr>
          <p:cNvSpPr txBox="1"/>
          <p:nvPr/>
        </p:nvSpPr>
        <p:spPr>
          <a:xfrm>
            <a:off x="7514249" y="493875"/>
            <a:ext cx="39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1105319-8CC2-04E8-53CB-D5D4A305F3B6}"/>
              </a:ext>
            </a:extLst>
          </p:cNvPr>
          <p:cNvSpPr txBox="1"/>
          <p:nvPr/>
        </p:nvSpPr>
        <p:spPr>
          <a:xfrm>
            <a:off x="7906400" y="526038"/>
            <a:ext cx="30691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eft Primer:      </a:t>
            </a:r>
            <a:r>
              <a:rPr lang="en-US" sz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CCTACTAAGTGCTCGGCTC</a:t>
            </a:r>
            <a:r>
              <a:rPr lang="en-US" sz="1200" dirty="0">
                <a:effectLst/>
              </a:rPr>
              <a:t> </a:t>
            </a:r>
            <a:r>
              <a:rPr lang="en-US" sz="1200" dirty="0"/>
              <a:t> </a:t>
            </a:r>
          </a:p>
          <a:p>
            <a:r>
              <a:rPr lang="en-US" sz="1200" dirty="0"/>
              <a:t>Right Primer:   </a:t>
            </a:r>
            <a:r>
              <a:rPr lang="en-US" sz="1200" dirty="0">
                <a:solidFill>
                  <a:srgbClr val="0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GTGACATTCCGGATCCCAA</a:t>
            </a:r>
            <a:r>
              <a:rPr lang="en-US" sz="1200" dirty="0">
                <a:effectLst/>
              </a:rPr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860963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219</Words>
  <Application>Microsoft Macintosh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ptos Narrow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egner, Daniel</dc:creator>
  <cp:lastModifiedBy>Wegner, Daniel</cp:lastModifiedBy>
  <cp:revision>2</cp:revision>
  <dcterms:created xsi:type="dcterms:W3CDTF">2024-12-12T17:20:17Z</dcterms:created>
  <dcterms:modified xsi:type="dcterms:W3CDTF">2024-12-12T17:53:28Z</dcterms:modified>
</cp:coreProperties>
</file>